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5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21" autoAdjust="0"/>
    <p:restoredTop sz="99901" autoAdjust="0"/>
  </p:normalViewPr>
  <p:slideViewPr>
    <p:cSldViewPr snapToGrid="0" snapToObjects="1">
      <p:cViewPr>
        <p:scale>
          <a:sx n="200" d="100"/>
          <a:sy n="200" d="100"/>
        </p:scale>
        <p:origin x="-280" y="-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920301-DCB5-3848-930D-6C078674DB53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BC0EA8-D580-C947-9062-0F48C0E007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23082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77748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7184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8463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2419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4776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13598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81891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676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8562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50761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5635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DF6A4B-C952-5B4E-AD9E-337DD81C987D}" type="datetimeFigureOut">
              <a:rPr kumimoji="1" lang="ja-JP" altLang="en-US" smtClean="0"/>
              <a:t>13/08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A51610-3791-D44C-9C13-2E25119F24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05544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96887715"/>
              </p:ext>
            </p:extLst>
          </p:nvPr>
        </p:nvGraphicFramePr>
        <p:xfrm>
          <a:off x="188640" y="251520"/>
          <a:ext cx="4217972" cy="2072120"/>
        </p:xfrm>
        <a:graphic>
          <a:graphicData uri="http://schemas.openxmlformats.org/drawingml/2006/table">
            <a:tbl>
              <a:tblPr/>
              <a:tblGrid>
                <a:gridCol w="584777"/>
                <a:gridCol w="563118"/>
                <a:gridCol w="771580"/>
                <a:gridCol w="487314"/>
                <a:gridCol w="1811183"/>
              </a:tblGrid>
              <a:tr h="151261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261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Table </a:t>
                      </a:r>
                      <a:r>
                        <a:rPr lang="en-US" sz="9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S2</a:t>
                      </a: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. Profile of antibodies used in this study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54514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2647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ntigen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onjugation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lone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ource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26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D117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(c-Kit)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E-Cy7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4D2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BD Biosciences ( San Jose, CA )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626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D11b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rizon V450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CRF44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D Biosciences ( San Jose, CA )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26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D11c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rizon V450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-ly6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D Biosciences ( San Jose, CA )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26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D3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rizon V450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UCHT1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D Biosciences ( San Jose, CA )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26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D19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rizon V450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IB19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D Biosciences ( San Jose, CA )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26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D56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rizon V450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159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D Biosciences ( San Jose, CA )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26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D45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rizon V500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I30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D Biosciences ( San Jose, CA )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264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c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Symbol"/>
                        </a:rPr>
                        <a:t>e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I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Symbol"/>
                        </a:rPr>
                        <a:t>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ITC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RA-1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yokuto ( Tokyo, JAPAN )</a:t>
                      </a: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261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8132" marR="8132" marT="81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9371790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5</TotalTime>
  <Words>117</Words>
  <Application>Microsoft Macintosh PowerPoint</Application>
  <PresentationFormat>画面に合わせる 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永井 恵</dc:creator>
  <cp:lastModifiedBy>永井 恵</cp:lastModifiedBy>
  <cp:revision>41</cp:revision>
  <dcterms:created xsi:type="dcterms:W3CDTF">2013-06-24T12:55:05Z</dcterms:created>
  <dcterms:modified xsi:type="dcterms:W3CDTF">2013-08-29T04:23:36Z</dcterms:modified>
</cp:coreProperties>
</file>